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83" r:id="rId2"/>
    <p:sldId id="258" r:id="rId3"/>
    <p:sldId id="257" r:id="rId4"/>
    <p:sldId id="256" r:id="rId5"/>
    <p:sldId id="261" r:id="rId6"/>
    <p:sldId id="262" r:id="rId7"/>
    <p:sldId id="284" r:id="rId8"/>
    <p:sldId id="293" r:id="rId9"/>
    <p:sldId id="294" r:id="rId10"/>
    <p:sldId id="265" r:id="rId11"/>
    <p:sldId id="285" r:id="rId12"/>
    <p:sldId id="269" r:id="rId13"/>
    <p:sldId id="292" r:id="rId14"/>
    <p:sldId id="267" r:id="rId15"/>
    <p:sldId id="268" r:id="rId16"/>
    <p:sldId id="270" r:id="rId17"/>
    <p:sldId id="295" r:id="rId18"/>
    <p:sldId id="288" r:id="rId19"/>
    <p:sldId id="287" r:id="rId20"/>
    <p:sldId id="291" r:id="rId21"/>
  </p:sldIdLst>
  <p:sldSz cx="9144000" cy="6858000" type="screen4x3"/>
  <p:notesSz cx="6797675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FFFF64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2064" autoAdjust="0"/>
    <p:restoredTop sz="96705" autoAdjust="0"/>
  </p:normalViewPr>
  <p:slideViewPr>
    <p:cSldViewPr>
      <p:cViewPr>
        <p:scale>
          <a:sx n="80" d="100"/>
          <a:sy n="80" d="100"/>
        </p:scale>
        <p:origin x="-324" y="3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78773A-EDF9-4755-B39E-D54166A9B7F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6661"/>
            <a:ext cx="543814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1599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DC5FDB-359C-43F4-93EB-4279A3279D8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80134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DC5FDB-359C-43F4-93EB-4279A3279D85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115332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DC5FDB-359C-43F4-93EB-4279A3279D85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115332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3B6A7-227D-4E48-B3B8-FEDE9DED38D0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3421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lpeng@mail.hzau.edu.cn" TargetMode="External"/><Relationship Id="rId2" Type="http://schemas.openxmlformats.org/officeDocument/2006/relationships/hyperlink" Target="mailto:pengliangcai2007@sina.com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bbrc.hzau.edu.cn/" TargetMode="Externa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152400"/>
            <a:ext cx="5791200" cy="381000"/>
          </a:xfrm>
        </p:spPr>
        <p:txBody>
          <a:bodyPr>
            <a:noAutofit/>
          </a:bodyPr>
          <a:lstStyle/>
          <a:p>
            <a:pPr algn="just">
              <a:lnSpc>
                <a:spcPct val="2000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Materials for ‘Biotechnology for Biofuels’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5800" y="1085671"/>
            <a:ext cx="77723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 finalized determinant for complete lignocellulose enzymatic saccharification potential to maximize bioethanol production in bioenergy </a:t>
            </a:r>
            <a:r>
              <a:rPr lang="en-US" sz="1600" b="1" i="1" dirty="0" smtClean="0">
                <a:latin typeface="Arial" pitchFamily="34" charset="0"/>
                <a:cs typeface="Arial" pitchFamily="34" charset="0"/>
              </a:rPr>
              <a:t>Miscanthus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5800" y="2616046"/>
            <a:ext cx="76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Aftab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Alam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Ran Zhang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eng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Liu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Jiangfeng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Huang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Yanting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Wang, Zhen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Hu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Meysam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Madad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Dan Sun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Ruofe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 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Hu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Arthur J.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Ragauskas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Yuanyuan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Tu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Liangca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Peng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6975" y="4673446"/>
            <a:ext cx="772122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*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rrespondence: Tel: +86-27-87281765; Fax: +86-27-87280016.</a:t>
            </a:r>
            <a:r>
              <a:rPr lang="en-US" sz="1200" u="sng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US" sz="1200" u="sng" dirty="0" smtClean="0">
                <a:latin typeface="Arial" pitchFamily="34" charset="0"/>
                <a:cs typeface="Arial" pitchFamily="34" charset="0"/>
              </a:rPr>
            </a:br>
            <a:r>
              <a:rPr lang="en-US" sz="1200" dirty="0" smtClean="0">
                <a:latin typeface="Arial" pitchFamily="34" charset="0"/>
                <a:cs typeface="Arial" pitchFamily="34" charset="0"/>
              </a:rPr>
              <a:t>E-mail</a:t>
            </a:r>
            <a:r>
              <a:rPr lang="en-US" sz="1200" u="sng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US" sz="1200" dirty="0" smtClean="0">
                <a:latin typeface="Arial" pitchFamily="34" charset="0"/>
                <a:cs typeface="Arial" pitchFamily="34" charset="0"/>
                <a:hlinkClick r:id="rId2"/>
              </a:rPr>
              <a:t>pengliangcai2007@sina.co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;</a:t>
            </a:r>
            <a:r>
              <a:rPr lang="en-US" sz="1200" u="sng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u="sng" dirty="0" smtClean="0">
                <a:latin typeface="Arial" pitchFamily="34" charset="0"/>
                <a:cs typeface="Arial" pitchFamily="34" charset="0"/>
                <a:hlinkClick r:id="rId3"/>
              </a:rPr>
              <a:t>lpeng@mail.hzau.edu.c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</a:t>
            </a:r>
            <a:endParaRPr lang="en-US" sz="1200" u="sng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u="sng" dirty="0" smtClean="0">
                <a:latin typeface="Arial" pitchFamily="34" charset="0"/>
                <a:cs typeface="Arial" pitchFamily="34" charset="0"/>
              </a:rPr>
              <a:t>Web: </a:t>
            </a:r>
            <a:r>
              <a:rPr lang="en-US" sz="1200" u="sng" dirty="0" smtClean="0">
                <a:latin typeface="Arial" pitchFamily="34" charset="0"/>
                <a:cs typeface="Arial" pitchFamily="34" charset="0"/>
                <a:hlinkClick r:id="rId4"/>
              </a:rPr>
              <a:t>http://bbrc.hzau.edu.cn</a:t>
            </a:r>
            <a:r>
              <a:rPr lang="en-US" sz="1200" u="sng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609308970"/>
              </p:ext>
            </p:extLst>
          </p:nvPr>
        </p:nvGraphicFramePr>
        <p:xfrm>
          <a:off x="228600" y="844150"/>
          <a:ext cx="8686799" cy="4951796"/>
        </p:xfrm>
        <a:graphic>
          <a:graphicData uri="http://schemas.openxmlformats.org/drawingml/2006/table">
            <a:tbl>
              <a:tblPr/>
              <a:tblGrid>
                <a:gridCol w="541906"/>
                <a:gridCol w="774151"/>
                <a:gridCol w="1083812"/>
                <a:gridCol w="851566"/>
                <a:gridCol w="1018348"/>
                <a:gridCol w="294468"/>
                <a:gridCol w="541149"/>
                <a:gridCol w="685541"/>
                <a:gridCol w="965286"/>
                <a:gridCol w="965286"/>
                <a:gridCol w="965286"/>
              </a:tblGrid>
              <a:tr h="2988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ulose features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ulose features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I (%)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P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I (%)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P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30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79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4±7.0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1±6.9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55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4±7.6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4±7.9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1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7±3.7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2±8.7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35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9±7.5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7±2.6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6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00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57±14.9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8±8.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0.73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9±10.5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4±11.5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12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16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7±6.8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0±7.1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77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78±8.6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6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7±6.4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913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1832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87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63±3.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05±9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5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49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4±9.0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4±6.8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63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8±6.8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4±8.2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34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06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8±8.6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2±5.6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45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83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86±17.8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9±7.4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88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3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0±9.2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0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9±8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12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4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7±5.1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2±8.1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5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49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1±3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01±1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标题 3"/>
          <p:cNvSpPr>
            <a:spLocks noGrp="1"/>
          </p:cNvSpPr>
          <p:nvPr>
            <p:ph type="title"/>
          </p:nvPr>
        </p:nvSpPr>
        <p:spPr>
          <a:xfrm>
            <a:off x="152400" y="381000"/>
            <a:ext cx="8686800" cy="4572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ble S8 </a:t>
            </a:r>
            <a:r>
              <a:rPr lang="en-US" altLang="zh-CN" sz="10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ellulose features (CrI and DP) </a:t>
            </a:r>
            <a:r>
              <a:rPr lang="en-US" altLang="zh-CN" sz="1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of </a:t>
            </a:r>
            <a:r>
              <a:rPr lang="en-US" altLang="zh-CN" sz="10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aw materials </a:t>
            </a:r>
            <a:r>
              <a:rPr lang="en-US" altLang="zh-CN" sz="1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nd the biomass residues obtained from three optimal pretreatments</a:t>
            </a:r>
            <a:endParaRPr lang="zh-CN" altLang="en-US" sz="10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标题 3"/>
          <p:cNvSpPr txBox="1">
            <a:spLocks/>
          </p:cNvSpPr>
          <p:nvPr/>
        </p:nvSpPr>
        <p:spPr>
          <a:xfrm>
            <a:off x="838200" y="5867400"/>
            <a:ext cx="75438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altLang="zh-CN" sz="900" dirty="0">
                <a:latin typeface="Arial" pitchFamily="34" charset="0"/>
                <a:cs typeface="Arial" pitchFamily="34" charset="0"/>
              </a:rPr>
              <a:t>The data as means ± 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SD (n = 3).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** as significant difference between raw material and pretreated residue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.</a:t>
            </a:r>
            <a:endParaRPr kumimoji="0" lang="zh-CN" altLang="en-US" sz="9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106964885"/>
              </p:ext>
            </p:extLst>
          </p:nvPr>
        </p:nvGraphicFramePr>
        <p:xfrm>
          <a:off x="228600" y="844150"/>
          <a:ext cx="8686801" cy="4951796"/>
        </p:xfrm>
        <a:graphic>
          <a:graphicData uri="http://schemas.openxmlformats.org/drawingml/2006/table">
            <a:tbl>
              <a:tblPr/>
              <a:tblGrid>
                <a:gridCol w="470452"/>
                <a:gridCol w="672074"/>
                <a:gridCol w="940904"/>
                <a:gridCol w="640397"/>
                <a:gridCol w="736169"/>
                <a:gridCol w="736169"/>
                <a:gridCol w="223435"/>
                <a:gridCol w="609600"/>
                <a:gridCol w="639304"/>
                <a:gridCol w="1030637"/>
                <a:gridCol w="662553"/>
                <a:gridCol w="662553"/>
                <a:gridCol w="662554"/>
              </a:tblGrid>
              <a:tr h="2988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onosaccharides (% of total)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onosaccharides (% of total)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84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r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Xyl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X/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ra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Xyl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X/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30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6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5.9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6.66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5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1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7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8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1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4.70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9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4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2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6.3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3.0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09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5.7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3.2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7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5.4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4.8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9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3.2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5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16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3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3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9.17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3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2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8.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30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0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6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8.46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9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3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9.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12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.1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1.3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.24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.7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1.1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0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3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3.5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5.7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0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4.3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8.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913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1832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6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5.9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6.56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8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5.8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5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5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4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1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0.04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3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2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1.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84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6.3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2.8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07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5.6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2.9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34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.4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2.4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4.41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.8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0.1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.9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45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8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1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5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0.54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.5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6.0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7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988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9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6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1.01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.1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7.2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4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12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.3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2.1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.51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.3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3.26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4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5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.6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3.6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6.60</a:t>
                      </a: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.0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3.5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.1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标题 3"/>
          <p:cNvSpPr>
            <a:spLocks noGrp="1"/>
          </p:cNvSpPr>
          <p:nvPr>
            <p:ph type="title"/>
          </p:nvPr>
        </p:nvSpPr>
        <p:spPr>
          <a:xfrm>
            <a:off x="152400" y="381000"/>
            <a:ext cx="8915400" cy="457200"/>
          </a:xfrm>
        </p:spPr>
        <p:txBody>
          <a:bodyPr>
            <a:noAutofit/>
          </a:bodyPr>
          <a:lstStyle/>
          <a:p>
            <a:pPr algn="just"/>
            <a:r>
              <a:rPr lang="en-US" altLang="zh-CN" sz="11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ble S9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Hemicellulose monosaccharides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omposition </a:t>
            </a:r>
            <a:r>
              <a:rPr lang="en-US" altLang="zh-CN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of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aw materials </a:t>
            </a:r>
            <a:r>
              <a:rPr lang="en-US" altLang="zh-CN" sz="11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nd the biomass residues obtained from three optimal pretreatments</a:t>
            </a:r>
            <a:endParaRPr lang="zh-CN" altLang="en-US" sz="11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064850523"/>
              </p:ext>
            </p:extLst>
          </p:nvPr>
        </p:nvGraphicFramePr>
        <p:xfrm>
          <a:off x="152396" y="838201"/>
          <a:ext cx="8763011" cy="4792697"/>
        </p:xfrm>
        <a:graphic>
          <a:graphicData uri="http://schemas.openxmlformats.org/drawingml/2006/table">
            <a:tbl>
              <a:tblPr/>
              <a:tblGrid>
                <a:gridCol w="479212"/>
                <a:gridCol w="739992"/>
                <a:gridCol w="990600"/>
                <a:gridCol w="685800"/>
                <a:gridCol w="685800"/>
                <a:gridCol w="762000"/>
                <a:gridCol w="152400"/>
                <a:gridCol w="609600"/>
                <a:gridCol w="724677"/>
                <a:gridCol w="876304"/>
                <a:gridCol w="685542"/>
                <a:gridCol w="685542"/>
                <a:gridCol w="685542"/>
              </a:tblGrid>
              <a:tr h="2668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/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G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/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0646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8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6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61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1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65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6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619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124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9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87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138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6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461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36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8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7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562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5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2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9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0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3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06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1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6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74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2</a:t>
                      </a:r>
                    </a:p>
                  </a:txBody>
                  <a:tcPr marL="8684" marR="8684" marT="86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标题 3"/>
          <p:cNvSpPr>
            <a:spLocks noGrp="1"/>
          </p:cNvSpPr>
          <p:nvPr>
            <p:ph type="title"/>
          </p:nvPr>
        </p:nvSpPr>
        <p:spPr>
          <a:xfrm>
            <a:off x="152400" y="381000"/>
            <a:ext cx="8763000" cy="457200"/>
          </a:xfrm>
        </p:spPr>
        <p:txBody>
          <a:bodyPr>
            <a:normAutofit/>
          </a:bodyPr>
          <a:lstStyle/>
          <a:p>
            <a:pPr algn="just" eaLnBrk="1" hangingPunct="1"/>
            <a:r>
              <a:rPr lang="en-US" altLang="zh-CN" sz="11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ble S10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hree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monomer </a:t>
            </a:r>
            <a:r>
              <a:rPr lang="en-US" altLang="zh-CN" sz="11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ratios of lignin in raw materials and the biomass residues obtained from three optimal pretreatments</a:t>
            </a:r>
            <a:endParaRPr lang="zh-CN" altLang="en-US" sz="11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81000" y="533400"/>
            <a:ext cx="8305800" cy="304800"/>
          </a:xfrm>
        </p:spPr>
        <p:txBody>
          <a:bodyPr>
            <a:noAutofit/>
          </a:bodyPr>
          <a:lstStyle/>
          <a:p>
            <a:pPr algn="just"/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able S11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Characteristic bands of the FTIR spectra in biomass residues as referred from previous studies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457200" y="823957"/>
          <a:ext cx="8153400" cy="4662443"/>
        </p:xfrm>
        <a:graphic>
          <a:graphicData uri="http://schemas.openxmlformats.org/drawingml/2006/table">
            <a:tbl>
              <a:tblPr/>
              <a:tblGrid>
                <a:gridCol w="1219200"/>
                <a:gridCol w="1371600"/>
                <a:gridCol w="2819400"/>
                <a:gridCol w="1828800"/>
                <a:gridCol w="914400"/>
              </a:tblGrid>
              <a:tr h="9410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ported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wave number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cm</a:t>
                      </a:r>
                      <a:r>
                        <a:rPr lang="en-US" sz="1000" b="1" baseline="30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-1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)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Observed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wave number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(cm</a:t>
                      </a:r>
                      <a:r>
                        <a:rPr lang="en-US" sz="1000" b="1" baseline="30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-1</a:t>
                      </a: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)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Functional group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Assignment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Reference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74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29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31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 breathing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H-lignin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1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5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98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898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 vibration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2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4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051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051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O-C ring skeletal vibration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Hemicelluloses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3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4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163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164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O-C asymmetric stretching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4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37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247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247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O-C stretching of aryl-alkyl ether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Lignin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5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1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373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371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scissoring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4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1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430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430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bending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6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4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460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460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</a:t>
                      </a:r>
                      <a:r>
                        <a:rPr lang="en-US" sz="1000" baseline="-25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asymmetric bending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Lignin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7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37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515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511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=C stretching of the  aromatic ring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Lignin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3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1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590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598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=C stretching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Lignin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7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1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603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603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=C stretching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Lignin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8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375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735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1735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=O stretching of acetyl or carboxylic acid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Hemicelluloses &amp; lignin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Calibri"/>
                        <a:cs typeface="Arial" pitchFamily="34" charset="0"/>
                      </a:endParaRP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9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4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900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2900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-H stretching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10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24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350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3378 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O-H stretching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Cellulose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itchFamily="34" charset="0"/>
                          <a:ea typeface="Calibri"/>
                          <a:cs typeface="Arial" pitchFamily="34" charset="0"/>
                        </a:rPr>
                        <a:t>[10]</a:t>
                      </a:r>
                    </a:p>
                  </a:txBody>
                  <a:tcPr marL="3316" marR="3316" marT="331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294901586"/>
              </p:ext>
            </p:extLst>
          </p:nvPr>
        </p:nvGraphicFramePr>
        <p:xfrm>
          <a:off x="152400" y="793812"/>
          <a:ext cx="8762998" cy="5404198"/>
        </p:xfrm>
        <a:graphic>
          <a:graphicData uri="http://schemas.openxmlformats.org/drawingml/2006/table">
            <a:tbl>
              <a:tblPr/>
              <a:tblGrid>
                <a:gridCol w="513469"/>
                <a:gridCol w="858131"/>
                <a:gridCol w="1066800"/>
                <a:gridCol w="990600"/>
                <a:gridCol w="1066800"/>
                <a:gridCol w="1152229"/>
                <a:gridCol w="941336"/>
                <a:gridCol w="1026912"/>
                <a:gridCol w="1146721"/>
              </a:tblGrid>
              <a:tr h="228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Y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B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/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ot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ye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mg/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Y/B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)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 max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/g)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727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27±0.16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41±0.71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0.68±0.86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0±0.0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.12±0.19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.33±1.28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11±0.5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20±0.7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.31±1.2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0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45±0.5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.14±0.9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93±0.2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38±0.5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31±0.7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7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60±0.5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.04±0.8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4.17±0.1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14±0.21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5.31±0.4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5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24±0.1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8.94±0.8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055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96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.18±0.29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91±0.66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1.08±0.37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88±0.0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9.07±0.48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.16±1.55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01±0.3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89±0.5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90±0.1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7±0.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86±0.8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9.40±1.5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37±0.4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13±0.59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9.50±0.1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7±0.0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93±0.86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0.35±1.0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31±0.8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33±0.4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2.64±1.2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2±0.01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46±0.9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.62±0.1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0556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961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26±0.4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.95±0.98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4.20±1.40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1±0.0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2.20±0.60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.44±0.19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19±0.7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98±0.42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4.17±1.15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2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14±0.7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09±1.4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5.92±0.7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68±0.6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.60±1.3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7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42±0.5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6.10±0.2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72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66±0.3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02±0.3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0.68±0.0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6±0.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63±0.6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6.05±0.3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374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39±0.51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.55±0.58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1.94±0.07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7±0.03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06±0.93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.21±0.86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39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18±0.7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.27±0.54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45±1.2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9±00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33±1.0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9.08±2.2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0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65±0.6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.16±0.58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81±0.1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±0.03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43±0.7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7.35±0.75</a:t>
                      </a: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61±0.6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75±0.5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1.36±0.1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7±0.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93±0.8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87±0.7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243" marR="6243" marT="62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itle 4"/>
          <p:cNvSpPr>
            <a:spLocks noGrp="1"/>
          </p:cNvSpPr>
          <p:nvPr>
            <p:ph type="title"/>
          </p:nvPr>
        </p:nvSpPr>
        <p:spPr>
          <a:xfrm>
            <a:off x="152400" y="304800"/>
            <a:ext cx="8839200" cy="533400"/>
          </a:xfrm>
        </p:spPr>
        <p:txBody>
          <a:bodyPr>
            <a:noAutofit/>
          </a:bodyPr>
          <a:lstStyle/>
          <a:p>
            <a:pPr algn="just"/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able S12-1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Biomass porosity of raw materials and the biomass residues obtained from three optimal pretreatments in four pairs of </a:t>
            </a:r>
            <a:r>
              <a:rPr lang="en-US" sz="1000" i="1" dirty="0" err="1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ccessions including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Simons stains (DY, DB, Total, Y/B), Congo red dye (CR) and mixed-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cellulase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enzyme adsorption (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Emax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5" name="Title 4"/>
          <p:cNvSpPr txBox="1">
            <a:spLocks/>
          </p:cNvSpPr>
          <p:nvPr/>
        </p:nvSpPr>
        <p:spPr bwMode="auto">
          <a:xfrm>
            <a:off x="76200" y="6172200"/>
            <a:ext cx="89916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just"/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 gram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of Congo red dye adsorbed  to cellulose corresponds to the area of 1055 m</a:t>
            </a:r>
            <a:r>
              <a:rPr lang="en-US" altLang="zh-CN" sz="8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sz="800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b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Enzyme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adsorption  (E max) was perform at non-cellulolytic condition (4ºC for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5 h) 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to elucidate enzyme accessibility to the porous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iomass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. The data as means ± SD (n = 3)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* and **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as significant difference between the raw material and  pretreated biomass residues by t-test at </a:t>
            </a:r>
            <a:r>
              <a:rPr lang="en-US" sz="8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&lt; 0.05 or &lt; 0.01 (n = 3)</a:t>
            </a:r>
            <a:endParaRPr lang="zh-CN" altLang="en-US" sz="8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589997753"/>
              </p:ext>
            </p:extLst>
          </p:nvPr>
        </p:nvGraphicFramePr>
        <p:xfrm>
          <a:off x="76200" y="807099"/>
          <a:ext cx="8839201" cy="5288901"/>
        </p:xfrm>
        <a:graphic>
          <a:graphicData uri="http://schemas.openxmlformats.org/drawingml/2006/table">
            <a:tbl>
              <a:tblPr/>
              <a:tblGrid>
                <a:gridCol w="514917"/>
                <a:gridCol w="858174"/>
                <a:gridCol w="1115626"/>
                <a:gridCol w="1115626"/>
                <a:gridCol w="943991"/>
                <a:gridCol w="1201443"/>
                <a:gridCol w="858174"/>
                <a:gridCol w="1115626"/>
                <a:gridCol w="1115624"/>
              </a:tblGrid>
              <a:tr h="2929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Pre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Y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B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/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otal dye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/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Y/B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)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 max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g/g)</a:t>
                      </a:r>
                      <a:r>
                        <a:rPr lang="en-US" sz="1000" b="1" i="0" u="none" strike="noStrike" baseline="30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1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.73±0.54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53±0.58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4.26±1.12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8±0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2.47±0.8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.21±2.08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20±0.6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30±0.5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50±1.2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8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56±0.7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5.47±0.8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70±0.5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54±0.5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6.24±1.1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9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76±0.9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15±1.8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24±0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23±0.7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2.47±0.2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0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66±0.7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9.81±1.4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629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4.05±0.54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.02±0.65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0.07±1.19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5±0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.03±0.88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4.86±0.05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07±0.5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2.50±0.66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.57±0.1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0±0.03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87±0.5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2.02±1.2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31±0.5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3.78±0.61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09±1.2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9±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05±0.8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9.73±1.3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77±0.6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08±0.62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85±0.0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9±03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40±0.7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91±0.71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6292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.23±0.45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9.03±1.27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7.27±0.82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8±0.04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57±0.77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.54±0.41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15±0.05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74±0.1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6.89±0.1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±0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67±0.7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4.99±0.4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6.88±0.1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14±0.28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02±0.15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3±0.01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61±0.6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4.56±0.5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2.39±0.0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94±0.15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3.34±0.0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2±0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87±0.8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9.04±0.6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629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397" marR="8397" marT="839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.09±0.31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.58±0.66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4.67±0.35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94±0.02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.18±0.66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.90±1.00</a:t>
                      </a: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.92±0.2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85±0.0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77±0.1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1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20±0.6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9.93±0.9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24±0.2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52±0.3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76±0.1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2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52±0.8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6.51±0.6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1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89" marR="7389" marT="73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43±0.2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14±0.0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7.58±0.2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±0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47±0.7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9.40±1.1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169" marR="6169" marT="616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itle 4"/>
          <p:cNvSpPr>
            <a:spLocks noGrp="1"/>
          </p:cNvSpPr>
          <p:nvPr>
            <p:ph type="title"/>
          </p:nvPr>
        </p:nvSpPr>
        <p:spPr>
          <a:xfrm>
            <a:off x="152400" y="304800"/>
            <a:ext cx="8839200" cy="533400"/>
          </a:xfrm>
        </p:spPr>
        <p:txBody>
          <a:bodyPr>
            <a:noAutofit/>
          </a:bodyPr>
          <a:lstStyle/>
          <a:p>
            <a:pPr algn="just"/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able S12-2 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Biomass porosity of raw materials and the biomass residues obtained from three optimal pretreatments in four pairs of </a:t>
            </a:r>
            <a:r>
              <a:rPr lang="en-US" altLang="zh-CN" sz="1000" i="1" dirty="0" err="1">
                <a:latin typeface="Arial" pitchFamily="34" charset="0"/>
                <a:cs typeface="Arial" pitchFamily="34" charset="0"/>
              </a:rPr>
              <a:t>Miscanthus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accessions including Simons stains (DY, DB, Total, Y/B), Congo red dye (CR) and mixed-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cellulase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enzyme adsorption (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Emax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)</a:t>
            </a:r>
            <a:endParaRPr lang="en-US" altLang="zh-CN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itle 4"/>
          <p:cNvSpPr txBox="1">
            <a:spLocks/>
          </p:cNvSpPr>
          <p:nvPr/>
        </p:nvSpPr>
        <p:spPr bwMode="auto">
          <a:xfrm>
            <a:off x="76200" y="6172200"/>
            <a:ext cx="89916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just"/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 gram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of Congo red dye adsorbed  to cellulose corresponds to the area of 1055 m</a:t>
            </a:r>
            <a:r>
              <a:rPr lang="en-US" altLang="zh-CN" sz="8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sz="800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b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Enzyme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adsorption  (E max) was perform at non-cellulolytic condition (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4 ºC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for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15 h)  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to elucidate enzyme accessibility to the porous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biomass</a:t>
            </a:r>
            <a:r>
              <a:rPr lang="en-US" altLang="zh-CN" sz="800" dirty="0">
                <a:latin typeface="Arial" pitchFamily="34" charset="0"/>
                <a:cs typeface="Arial" pitchFamily="34" charset="0"/>
              </a:rPr>
              <a:t>. The data as means ± SD (n = 3)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* and ** 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as significant difference between the raw material and  pretreated biomass residues by t-test at </a:t>
            </a:r>
            <a:r>
              <a:rPr lang="en-US" sz="8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&lt; 0.05 or &lt; 0.01 (n = 3)</a:t>
            </a:r>
            <a:endParaRPr lang="zh-CN" altLang="en-US" sz="8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019614266"/>
              </p:ext>
            </p:extLst>
          </p:nvPr>
        </p:nvGraphicFramePr>
        <p:xfrm>
          <a:off x="1067553" y="1600200"/>
          <a:ext cx="6629401" cy="1384525"/>
        </p:xfrm>
        <a:graphic>
          <a:graphicData uri="http://schemas.openxmlformats.org/drawingml/2006/table">
            <a:tbl>
              <a:tblPr/>
              <a:tblGrid>
                <a:gridCol w="1751847"/>
                <a:gridCol w="944606"/>
                <a:gridCol w="983237"/>
                <a:gridCol w="983237"/>
                <a:gridCol w="983237"/>
                <a:gridCol w="983237"/>
              </a:tblGrid>
              <a:tr h="305480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ore characteristi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LHW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H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sz="1000" b="1" i="0" u="none" strike="noStrike" baseline="-25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ptimal NaO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92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ET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urface area (m²/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928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9680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JH pore volume (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m³/mg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928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990600" y="990600"/>
            <a:ext cx="67056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Table S1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Pore characteristics (specific surface area and cumulative pore volume) in the representative Pair II of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samples determined by BET and BJH methods from nitrogen adsorption porosimetry.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914400" y="2368486"/>
          <a:ext cx="7239000" cy="1793875"/>
        </p:xfrm>
        <a:graphic>
          <a:graphicData uri="http://schemas.openxmlformats.org/drawingml/2006/table">
            <a:tbl>
              <a:tblPr/>
              <a:tblGrid>
                <a:gridCol w="1143000"/>
                <a:gridCol w="1083203"/>
                <a:gridCol w="1087364"/>
                <a:gridCol w="1080022"/>
                <a:gridCol w="279181"/>
                <a:gridCol w="1039035"/>
                <a:gridCol w="300535"/>
                <a:gridCol w="1226660"/>
              </a:tblGrid>
              <a:tr h="3327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Simons stain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CR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(Congo red)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E max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(</a:t>
                      </a:r>
                      <a:r>
                        <a:rPr lang="en-US" sz="10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Enzyme</a:t>
                      </a:r>
                      <a:r>
                        <a:rPr lang="en-US" sz="1000" b="1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 </a:t>
                      </a:r>
                      <a:r>
                        <a:rPr lang="en-US" sz="10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adsorption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)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27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DY (yellow dye)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Total dye</a:t>
                      </a:r>
                      <a:b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</a:b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(DY+DB)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Y/B</a:t>
                      </a: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/>
                      </a:r>
                      <a:b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</a:b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(DY/DB ratio)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984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Hexose</a:t>
                      </a:r>
                      <a:r>
                        <a:rPr lang="en-US" sz="10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yield 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22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24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822**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60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05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984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Bioethanol yield 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03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07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779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46**</a:t>
                      </a: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00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latin typeface="Arial" pitchFamily="34" charset="0"/>
                          <a:ea typeface="SimSun"/>
                          <a:cs typeface="Arial" pitchFamily="34" charset="0"/>
                        </a:rPr>
                        <a:t>.917**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itchFamily="34" charset="0"/>
                        <a:ea typeface="SimSun"/>
                        <a:cs typeface="Arial" pitchFamily="34" charset="0"/>
                      </a:endParaRPr>
                    </a:p>
                  </a:txBody>
                  <a:tcPr marL="6985" marR="6985" marT="6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6385" name="Rectangle 1"/>
          <p:cNvSpPr>
            <a:spLocks noChangeArrowheads="1"/>
          </p:cNvSpPr>
          <p:nvPr/>
        </p:nvSpPr>
        <p:spPr bwMode="auto">
          <a:xfrm>
            <a:off x="838200" y="1905000"/>
            <a:ext cx="731520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able S14 Correlation coefficients (Spearman rank) between </a:t>
            </a:r>
            <a:r>
              <a:rPr kumimoji="0" lang="en-US" sz="100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hexose</a:t>
            </a:r>
            <a:r>
              <a:rPr kumimoji="0" lang="en-US" sz="10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/bioethanol yields and major factors of biomass porosity in raw materials and three optimal pretreated biomass residues of four pairs of samples</a:t>
            </a:r>
            <a:endParaRPr kumimoji="0" lang="en-US" sz="100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838200" y="4343400"/>
            <a:ext cx="73914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** as significant correlation at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&lt; 0.01 (n = 32).  DB as direct blue dye from Simons’ stain.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76200" y="1145348"/>
            <a:ext cx="8915400" cy="5334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Table 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S15 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Correlation coefficients (Spearman rank)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between 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hexose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/ethanol yields and major wall polymers features in four pairs of </a:t>
            </a:r>
            <a:r>
              <a:rPr lang="en-US" altLang="zh-CN" sz="1000" i="1" dirty="0">
                <a:latin typeface="Arial" pitchFamily="34" charset="0"/>
                <a:cs typeface="Arial" pitchFamily="34" charset="0"/>
              </a:rPr>
              <a:t>Miscanthus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samples</a:t>
            </a:r>
            <a:endParaRPr lang="en-US" altLang="zh-CN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标题 3"/>
          <p:cNvSpPr txBox="1">
            <a:spLocks/>
          </p:cNvSpPr>
          <p:nvPr/>
        </p:nvSpPr>
        <p:spPr>
          <a:xfrm>
            <a:off x="609600" y="4003675"/>
            <a:ext cx="41148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* and ** as significant correlation at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&lt; 0.05 and &lt; 0.01 (n = 32).</a:t>
            </a:r>
            <a:endParaRPr kumimoji="0" lang="zh-CN" altLang="en-US" sz="1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875887541"/>
              </p:ext>
            </p:extLst>
          </p:nvPr>
        </p:nvGraphicFramePr>
        <p:xfrm>
          <a:off x="76200" y="1600200"/>
          <a:ext cx="8915401" cy="2286000"/>
        </p:xfrm>
        <a:graphic>
          <a:graphicData uri="http://schemas.openxmlformats.org/drawingml/2006/table">
            <a:tbl>
              <a:tblPr/>
              <a:tblGrid>
                <a:gridCol w="689020"/>
                <a:gridCol w="530180"/>
                <a:gridCol w="533400"/>
                <a:gridCol w="533400"/>
                <a:gridCol w="152400"/>
                <a:gridCol w="609600"/>
                <a:gridCol w="533400"/>
                <a:gridCol w="685800"/>
                <a:gridCol w="609600"/>
                <a:gridCol w="152400"/>
                <a:gridCol w="609600"/>
                <a:gridCol w="533400"/>
                <a:gridCol w="533400"/>
                <a:gridCol w="533400"/>
                <a:gridCol w="533400"/>
                <a:gridCol w="533400"/>
                <a:gridCol w="609601"/>
              </a:tblGrid>
              <a:tr h="571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ulo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micellulose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gn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ve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ve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Xylo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rabinose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X/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ve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/G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/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xose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yiel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702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01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371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305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467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.354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378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862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851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873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884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547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0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646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thanol yiel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765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.006</a:t>
                      </a:r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354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273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-.525**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.413*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-.438*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855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848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864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875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583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-.0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-.642**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1835716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87715868"/>
              </p:ext>
            </p:extLst>
          </p:nvPr>
        </p:nvGraphicFramePr>
        <p:xfrm>
          <a:off x="1066799" y="1675955"/>
          <a:ext cx="7010401" cy="2417010"/>
        </p:xfrm>
        <a:graphic>
          <a:graphicData uri="http://schemas.openxmlformats.org/drawingml/2006/table">
            <a:tbl>
              <a:tblPr/>
              <a:tblGrid>
                <a:gridCol w="1447801"/>
                <a:gridCol w="1087686"/>
                <a:gridCol w="1106847"/>
                <a:gridCol w="969024"/>
                <a:gridCol w="1365424"/>
                <a:gridCol w="1033619"/>
              </a:tblGrid>
              <a:tr h="402835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ulose </a:t>
                      </a:r>
                    </a:p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micellulose</a:t>
                      </a:r>
                    </a:p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X/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gnin</a:t>
                      </a:r>
                    </a:p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-monom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Y (yellow dye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 (Congo red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28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ulose D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16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.458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559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464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2835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micellulose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X/A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0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432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454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28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ignin G-monome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842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.832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28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Y (yellow dye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.957**</a:t>
                      </a: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28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R (Congo red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b="0" dirty="0"/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04" marR="6804" marT="680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7290" name="Title 1"/>
          <p:cNvSpPr>
            <a:spLocks noGrp="1"/>
          </p:cNvSpPr>
          <p:nvPr>
            <p:ph type="title"/>
          </p:nvPr>
        </p:nvSpPr>
        <p:spPr>
          <a:xfrm>
            <a:off x="990600" y="1143000"/>
            <a:ext cx="7086600" cy="6096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able S16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Correlation coefficients (Spearman rank) among major wall polymer features and major factors of biomass porosity in four pairs of </a:t>
            </a:r>
            <a:r>
              <a:rPr lang="en-US" altLang="zh-CN" sz="1000" i="1" dirty="0" smtClean="0">
                <a:latin typeface="Arial" pitchFamily="34" charset="0"/>
                <a:cs typeface="Arial" pitchFamily="34" charset="0"/>
              </a:rPr>
              <a:t>Miscanthus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samples</a:t>
            </a:r>
          </a:p>
        </p:txBody>
      </p:sp>
      <p:sp>
        <p:nvSpPr>
          <p:cNvPr id="5" name="标题 3"/>
          <p:cNvSpPr txBox="1">
            <a:spLocks/>
          </p:cNvSpPr>
          <p:nvPr/>
        </p:nvSpPr>
        <p:spPr>
          <a:xfrm>
            <a:off x="990600" y="4156075"/>
            <a:ext cx="41148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000" dirty="0" smtClean="0">
                <a:latin typeface="Arial" pitchFamily="34" charset="0"/>
                <a:cs typeface="Arial" pitchFamily="34" charset="0"/>
              </a:rPr>
              <a:t>* and ** as significant correlation at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&lt; 0.05 and &lt; 0.01 (n = 32).</a:t>
            </a:r>
            <a:endParaRPr kumimoji="0" lang="zh-CN" altLang="en-US" sz="1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89212464"/>
              </p:ext>
            </p:extLst>
          </p:nvPr>
        </p:nvGraphicFramePr>
        <p:xfrm>
          <a:off x="76200" y="795909"/>
          <a:ext cx="8915399" cy="3699891"/>
        </p:xfrm>
        <a:graphic>
          <a:graphicData uri="http://schemas.openxmlformats.org/drawingml/2006/table">
            <a:tbl>
              <a:tblPr/>
              <a:tblGrid>
                <a:gridCol w="530679"/>
                <a:gridCol w="1061357"/>
                <a:gridCol w="1061357"/>
                <a:gridCol w="1061357"/>
                <a:gridCol w="1061357"/>
                <a:gridCol w="1061357"/>
                <a:gridCol w="1061357"/>
                <a:gridCol w="1061357"/>
                <a:gridCol w="955221"/>
              </a:tblGrid>
              <a:tr h="31350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incubation tim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13502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4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 m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350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33±0.4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13±1.3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.27±0.3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88±0.9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75±1.3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.38±0.66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09±0.8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35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44±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40±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62±0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.81±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13±1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67±0.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72±0.8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543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350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18±0.3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96±0.6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.54±0.8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64±1.1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82±1.10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63±0.9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D </a:t>
                      </a:r>
                      <a:endParaRPr lang="en-US" sz="1000" b="0" i="0" u="none" strike="noStrike" baseline="30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35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1±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23±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61±0.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.65±0.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64±0.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55±0.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2588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350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53±0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74±0.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77±0.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47±0.7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60±1.04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92±1.2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35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76±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49±0.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.07±0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81±1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34±0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36±0.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6852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350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78±0.3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77±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4.42±0.5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59±0.8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3.62±1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24±0.62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40±0.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350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21±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36±0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39±0.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5.79±0.7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19±0.8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38±1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32±0.7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标题 3"/>
          <p:cNvSpPr txBox="1">
            <a:spLocks/>
          </p:cNvSpPr>
          <p:nvPr/>
        </p:nvSpPr>
        <p:spPr>
          <a:xfrm>
            <a:off x="152400" y="228600"/>
            <a:ext cx="8991600" cy="5683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just">
              <a:spcBef>
                <a:spcPct val="0"/>
              </a:spcBef>
            </a:pP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Table S1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r>
              <a:rPr kumimoji="0" lang="en-US" altLang="zh-CN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Hexose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yields (% cellulose) released from enzymatic hydrolysis after pretreatments with LHW under a time course in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four typical pairs of </a:t>
            </a:r>
            <a:r>
              <a:rPr lang="en-US" altLang="zh-CN" sz="1000" i="1" dirty="0" err="1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altLang="zh-CN" sz="10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accessions.</a:t>
            </a: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endParaRPr kumimoji="0" lang="zh-CN" altLang="en-US" sz="1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5" name="标题 3"/>
          <p:cNvSpPr txBox="1">
            <a:spLocks/>
          </p:cNvSpPr>
          <p:nvPr/>
        </p:nvSpPr>
        <p:spPr>
          <a:xfrm>
            <a:off x="350067" y="4648200"/>
            <a:ext cx="8596265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* and ** as significant difference between two samples of each pair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 (n = 3); </a:t>
            </a:r>
            <a:r>
              <a:rPr lang="en-US" altLang="zh-CN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D = Not detected. 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(H) and (L) represented two samples of each pair showing relatively high (H) and low (L) biomass </a:t>
            </a:r>
            <a:r>
              <a:rPr lang="en-US" altLang="zh-CN" sz="900" dirty="0" err="1">
                <a:latin typeface="Arial" pitchFamily="34" charset="0"/>
                <a:cs typeface="Arial" pitchFamily="34" charset="0"/>
              </a:rPr>
              <a:t>saccharification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. The data as means ± SD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zh-CN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1"/>
          <p:cNvSpPr>
            <a:spLocks noChangeArrowheads="1"/>
          </p:cNvSpPr>
          <p:nvPr/>
        </p:nvSpPr>
        <p:spPr bwMode="auto">
          <a:xfrm>
            <a:off x="381001" y="943210"/>
            <a:ext cx="8305800" cy="58923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indent="-457200"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1. Wu K, Shi Z, Yang H, Liao Z, Yang J. Effect of ethanol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organosolv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lignin from bamboo on enzymatic hydrolysis of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avice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 ACS Sustain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hem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ng 2017;5:1721–9. 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2.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oakye-Boate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NA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Xiu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S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Shahbaz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, Wang L, Li R, Mims M, et al. Effects of fertilizer application and dry/wet processing of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Miscanthus x </a:t>
            </a:r>
            <a:r>
              <a:rPr lang="en-US" sz="1000" i="1" dirty="0" err="1" smtClean="0">
                <a:latin typeface="Arial" pitchFamily="34" charset="0"/>
                <a:cs typeface="Arial" pitchFamily="34" charset="0"/>
              </a:rPr>
              <a:t>giganteu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on bioethanol production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resou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echn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6;204:98–105. 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3.  Zhou X, Li Q, Zhang Y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Gu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Y. Effect of hydrothermal pretreatment on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naerobic digestion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resou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echn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7;224:721–6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4.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Haqu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A, Barman DN, Kang TH, Kim MK, Kim J, Kim H, et al. Effect of dilute alkali pretreatment on structural features and enhanced enzymatic hydrolysis of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Miscanthus </a:t>
            </a:r>
            <a:r>
              <a:rPr lang="en-US" sz="1000" i="1" dirty="0" err="1" smtClean="0">
                <a:latin typeface="Arial" pitchFamily="34" charset="0"/>
                <a:cs typeface="Arial" pitchFamily="34" charset="0"/>
              </a:rPr>
              <a:t>sinensis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at boiling temperature with low residence time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syst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ng 2013;114:294–305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5.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Ravindra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R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Jaiswa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S, Abu-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Ghannam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N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Jaiswa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K. A comparative analysis of pretreatment strategies on the properties and hydrolysis of brewers’ spent grain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resou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echn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8;248:272–9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6.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Noor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S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arim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K. Detailed study of efficient ethanol production from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elmwoo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by alkali pretreatment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chem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ng J 2016;105:197–204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7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Goshadrou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arim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K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Lefsru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. Characterization of ionic liquid pretreated aspen wood using semi-quantitative methods for ethanol production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arbohyd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Polym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3;96:440–9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8. Sun SL, Sun SN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Wen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JL, Zhang XM, Peng F, Sun RC. Assessment of integrated process based on hydrothermal and alkaline treatments for enzymatic saccharification of sweet sorghum stems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Bioresou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Technol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5;175:473–9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9.  Wang Q, Wei W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Kingor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GP, Sun J. Cell wall disruption in low temperature NaOH/urea solution and its potential application in lignocellulose pretreatment. Cellulose 2015;22:3559–68.</a:t>
            </a:r>
          </a:p>
          <a:p>
            <a:pPr algn="just">
              <a:lnSpc>
                <a:spcPct val="200000"/>
              </a:lnSpc>
            </a:pPr>
            <a:r>
              <a:rPr lang="en-US" sz="1000" dirty="0" smtClean="0">
                <a:latin typeface="Arial" pitchFamily="34" charset="0"/>
                <a:cs typeface="Arial" pitchFamily="34" charset="0"/>
              </a:rPr>
              <a:t>10. 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Goshadrou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,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Lefsru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M. Synergistic surfactant-assisted [EMIM]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OAc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pretreatment of lignocellulosic waste for enhanced cellulose accessibility to cellulase.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arbohydr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Polym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2017;166:104–13.</a:t>
            </a:r>
          </a:p>
          <a:p>
            <a:pPr marL="0" marR="0" lvl="0" algn="just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标题 3"/>
          <p:cNvSpPr txBox="1">
            <a:spLocks/>
          </p:cNvSpPr>
          <p:nvPr/>
        </p:nvSpPr>
        <p:spPr>
          <a:xfrm>
            <a:off x="457200" y="574675"/>
            <a:ext cx="12954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References</a:t>
            </a:r>
            <a:endParaRPr kumimoji="0" lang="zh-CN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088675335"/>
              </p:ext>
            </p:extLst>
          </p:nvPr>
        </p:nvGraphicFramePr>
        <p:xfrm>
          <a:off x="152399" y="824865"/>
          <a:ext cx="8763003" cy="3747139"/>
        </p:xfrm>
        <a:graphic>
          <a:graphicData uri="http://schemas.openxmlformats.org/drawingml/2006/table">
            <a:tbl>
              <a:tblPr/>
              <a:tblGrid>
                <a:gridCol w="686292"/>
                <a:gridCol w="1176498"/>
                <a:gridCol w="1176498"/>
                <a:gridCol w="1470622"/>
                <a:gridCol w="1443886"/>
                <a:gridCol w="1490019"/>
                <a:gridCol w="1319188"/>
              </a:tblGrid>
              <a:tr h="3147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concentration (v/v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14734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7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33±0.4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89±0.6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06±0.4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72±0.6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.53±0.7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4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44±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77±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85±0.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14±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88±0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9933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47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18±0.3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75±0.3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43±0.56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16±0.2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53±0.5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4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1±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.49±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33±0.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11±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46±0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933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47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53±0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3.05±0.2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67±0.3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65±0.33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23±0.6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4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76±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85±0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19±0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03±0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88±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9933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1473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78±0.3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86±0.2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06±0.1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46±0.75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76±0.5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47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(L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21±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31±0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10±0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78±0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16±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标题 3"/>
          <p:cNvSpPr txBox="1">
            <a:spLocks/>
          </p:cNvSpPr>
          <p:nvPr/>
        </p:nvSpPr>
        <p:spPr>
          <a:xfrm>
            <a:off x="76200" y="304800"/>
            <a:ext cx="88392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just">
              <a:spcBef>
                <a:spcPct val="0"/>
              </a:spcBef>
            </a:pP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Table S2 </a:t>
            </a:r>
            <a:r>
              <a:rPr kumimoji="0" lang="en-US" altLang="zh-CN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Hexose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yields (% cellulose) released from enzymatic hydrolysis after H</a:t>
            </a:r>
            <a:r>
              <a:rPr kumimoji="0" lang="en-US" altLang="zh-CN" sz="1000" b="0" i="0" u="none" strike="noStrike" kern="1200" cap="none" spc="0" normalizeH="0" baseline="-2500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2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SO</a:t>
            </a:r>
            <a:r>
              <a:rPr kumimoji="0" lang="en-US" altLang="zh-CN" sz="1000" b="0" i="0" u="none" strike="noStrike" kern="1200" cap="none" spc="0" normalizeH="0" baseline="-2500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4 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pretreatments</a:t>
            </a:r>
            <a:r>
              <a:rPr kumimoji="0" lang="en-US" altLang="zh-CN" sz="10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with a series 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concentrations in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four typical pairs of </a:t>
            </a:r>
            <a:r>
              <a:rPr lang="en-US" altLang="zh-CN" sz="1000" i="1" dirty="0" err="1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accessions.</a:t>
            </a: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endParaRPr kumimoji="0" lang="zh-CN" altLang="en-US" sz="1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6" name="标题 3"/>
          <p:cNvSpPr txBox="1">
            <a:spLocks/>
          </p:cNvSpPr>
          <p:nvPr/>
        </p:nvSpPr>
        <p:spPr>
          <a:xfrm>
            <a:off x="350067" y="4648200"/>
            <a:ext cx="8596265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* and ** as significant difference between two samples of each pair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 (n = 3); </a:t>
            </a:r>
            <a:r>
              <a:rPr lang="en-US" altLang="zh-CN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D = Not detected. 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(H) and (L) represented two samples of each pair showing relatively high (H) and low (L) biomass </a:t>
            </a:r>
            <a:r>
              <a:rPr lang="en-US" altLang="zh-CN" sz="900" dirty="0" err="1">
                <a:latin typeface="Arial" pitchFamily="34" charset="0"/>
                <a:cs typeface="Arial" pitchFamily="34" charset="0"/>
              </a:rPr>
              <a:t>saccharification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. The data as means ± SD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zh-CN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290676544"/>
              </p:ext>
            </p:extLst>
          </p:nvPr>
        </p:nvGraphicFramePr>
        <p:xfrm>
          <a:off x="76198" y="838201"/>
          <a:ext cx="8839203" cy="3733799"/>
        </p:xfrm>
        <a:graphic>
          <a:graphicData uri="http://schemas.openxmlformats.org/drawingml/2006/table">
            <a:tbl>
              <a:tblPr/>
              <a:tblGrid>
                <a:gridCol w="623941"/>
                <a:gridCol w="1039906"/>
                <a:gridCol w="1247888"/>
                <a:gridCol w="1247888"/>
                <a:gridCol w="1351879"/>
                <a:gridCol w="1247888"/>
                <a:gridCol w="1143897"/>
                <a:gridCol w="935916"/>
              </a:tblGrid>
              <a:tr h="327347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centration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(w/v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11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%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22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33±0.4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9.14±1.8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1.48±2.5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2.85±1.5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1.54±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D</a:t>
                      </a:r>
                      <a:endParaRPr lang="en-US" sz="1000" b="0" i="0" u="none" strike="noStrike" baseline="30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11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44±0.3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00±0.81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.55±0.17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81±0.35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6.16±1.15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72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18±0.3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9.88±0.5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.46±1.20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.48±2.07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.87±2.0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1±0.19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08±0.25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2.29±0.57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99±1.48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13±1.12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72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53±0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.08±1.1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5.80±1.0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0.81±0.72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0.58±2.0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76±0.09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.61±0.98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79±2.38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9.50±1.23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3.13±1.26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72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78±0.3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3.09±1.6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7.20±0.6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5.43±2.2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0.05±0.38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**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0.01±2.14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17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21±0.37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23±1.01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48±0.36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3.06±0.25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6.24±1.13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4.54±1.50</a:t>
                      </a:r>
                    </a:p>
                  </a:txBody>
                  <a:tcPr marL="7327" marR="7327" marT="73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标题 3"/>
          <p:cNvSpPr txBox="1">
            <a:spLocks/>
          </p:cNvSpPr>
          <p:nvPr/>
        </p:nvSpPr>
        <p:spPr>
          <a:xfrm>
            <a:off x="76200" y="304800"/>
            <a:ext cx="88392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algn="just">
              <a:spcBef>
                <a:spcPct val="0"/>
              </a:spcBef>
            </a:pP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Table S3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r>
              <a:rPr kumimoji="0" lang="en-US" altLang="zh-CN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Hexose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yields (% cellulose) released from enzymatic hydrolysis after NaOH pretreatments</a:t>
            </a:r>
            <a:r>
              <a:rPr kumimoji="0" lang="en-US" altLang="zh-CN" sz="1000" b="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with a series </a:t>
            </a:r>
            <a:r>
              <a:rPr kumimoji="0" lang="en-US" altLang="zh-CN" sz="1000" b="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concentrations in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four typical pairs of </a:t>
            </a:r>
            <a:r>
              <a:rPr lang="en-US" altLang="zh-CN" sz="1000" i="1" dirty="0" err="1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accessions.</a:t>
            </a: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</a:t>
            </a:r>
            <a:endParaRPr kumimoji="0" lang="zh-CN" altLang="en-US" sz="1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9" name="标题 3"/>
          <p:cNvSpPr txBox="1">
            <a:spLocks/>
          </p:cNvSpPr>
          <p:nvPr/>
        </p:nvSpPr>
        <p:spPr>
          <a:xfrm>
            <a:off x="350067" y="4648200"/>
            <a:ext cx="8596265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* and ** as significant difference between two samples of each pair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 (n = 3); </a:t>
            </a:r>
            <a:r>
              <a:rPr lang="en-US" altLang="zh-CN" sz="9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D = Not detected. 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(H) and (L) represented two samples of each pair showing relatively high (H) and low (L) biomass </a:t>
            </a:r>
            <a:r>
              <a:rPr lang="en-US" altLang="zh-CN" sz="900" dirty="0" err="1">
                <a:latin typeface="Arial" pitchFamily="34" charset="0"/>
                <a:cs typeface="Arial" pitchFamily="34" charset="0"/>
              </a:rPr>
              <a:t>saccharification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. The data as means ± SD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zh-CN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3"/>
          <p:cNvSpPr>
            <a:spLocks noGrp="1"/>
          </p:cNvSpPr>
          <p:nvPr>
            <p:ph type="title" idx="4294967295"/>
          </p:nvPr>
        </p:nvSpPr>
        <p:spPr>
          <a:xfrm>
            <a:off x="174279" y="304800"/>
            <a:ext cx="8839199" cy="4572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able S4</a:t>
            </a:r>
            <a:r>
              <a:rPr lang="en-US" altLang="zh-CN" sz="10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000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Hexose</a:t>
            </a:r>
            <a:r>
              <a:rPr lang="en-US" altLang="zh-CN" sz="10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yields (% cellulose) released from enzymatic hydrolysis co-supplied with 1% Tween-80  after three optimal pretreatments in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four typical pairs of </a:t>
            </a:r>
            <a:r>
              <a:rPr lang="en-US" altLang="zh-CN" sz="1000" i="1" dirty="0" smtClean="0">
                <a:latin typeface="Arial" pitchFamily="34" charset="0"/>
                <a:cs typeface="Arial" pitchFamily="34" charset="0"/>
              </a:rPr>
              <a:t>Miscanthus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accessions.</a:t>
            </a:r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</a:t>
            </a:r>
            <a:endParaRPr lang="zh-CN" altLang="en-US" sz="1000" dirty="0" smtClean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510175532"/>
              </p:ext>
            </p:extLst>
          </p:nvPr>
        </p:nvGraphicFramePr>
        <p:xfrm>
          <a:off x="228602" y="838200"/>
          <a:ext cx="8686797" cy="4378744"/>
        </p:xfrm>
        <a:graphic>
          <a:graphicData uri="http://schemas.openxmlformats.org/drawingml/2006/table">
            <a:tbl>
              <a:tblPr/>
              <a:tblGrid>
                <a:gridCol w="494117"/>
                <a:gridCol w="1732246"/>
                <a:gridCol w="1113184"/>
                <a:gridCol w="1192694"/>
                <a:gridCol w="1416326"/>
                <a:gridCol w="1416326"/>
                <a:gridCol w="1321904"/>
              </a:tblGrid>
              <a:tr h="3048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6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out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 Twe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33±0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.38±0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06±0.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2.85±1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44±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67±0.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85±0.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81±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 Twe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74±0.4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.39±1.6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7.12±0.2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44±1.4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14±0.2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.25±1.5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5.78±0.6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3.85±0.4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96352"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356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out 1% Twee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18±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82±1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43±0.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.48±2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1±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.64±0.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33±0.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4.99±1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 Twe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85±0.2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.27±1.7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.85±1.0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7.30±0.8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87±0.7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04±1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81±0.7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2.68±2.0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85600"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356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out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 Twe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53±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.60±1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65±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0.81±0.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76±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34±0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03±0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9.50±1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% Twee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09±0.69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.82±1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5.76±1.5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00±1.48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93±0.4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90±0.8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92±0.9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.49±0.79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08381"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3562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out 1% Twee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78±0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24±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46±0.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0.05±0.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21±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38±1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78±0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6.24±1.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47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With 1% Twee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68±0.33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.19±1.1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3.06±1.4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00±2.5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356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.47±0.2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.34±1.7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1.30±1.2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.49±1.75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标题 3"/>
          <p:cNvSpPr txBox="1">
            <a:spLocks/>
          </p:cNvSpPr>
          <p:nvPr/>
        </p:nvSpPr>
        <p:spPr>
          <a:xfrm>
            <a:off x="395334" y="5181600"/>
            <a:ext cx="8596265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* and ** as significant difference between the control (without 1% Tween) and the sample with 1% Tween of each pair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 (n = 3); 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H) and (L) represented two samples of each pair showing relatively high (H) and low (L) biomass saccharification. The data as means ± SD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zh-CN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609600" y="1090620"/>
          <a:ext cx="7924800" cy="3176250"/>
        </p:xfrm>
        <a:graphic>
          <a:graphicData uri="http://schemas.openxmlformats.org/drawingml/2006/table">
            <a:tbl>
              <a:tblPr/>
              <a:tblGrid>
                <a:gridCol w="1251298"/>
                <a:gridCol w="1415944"/>
                <a:gridCol w="1306084"/>
                <a:gridCol w="1324443"/>
                <a:gridCol w="1302588"/>
                <a:gridCol w="1324443"/>
              </a:tblGrid>
              <a:tr h="27951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aw materi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H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41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21±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82±0.27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30±0.2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7.06±0.3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41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22±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04±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81±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80±0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54100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89±0.1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68±0.2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73±0.1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92±0.4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11±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12±0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66±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26±0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68±0.11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99±0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34±0.34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8.98±0.87*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668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04±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26±0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47±0.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51±0.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680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60±0.06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67±0.22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34±0.22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59±0.33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668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29±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54±0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79±0.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80±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标题 3"/>
          <p:cNvSpPr txBox="1">
            <a:spLocks/>
          </p:cNvSpPr>
          <p:nvPr/>
        </p:nvSpPr>
        <p:spPr>
          <a:xfrm>
            <a:off x="577913" y="457200"/>
            <a:ext cx="7924800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just">
              <a:spcBef>
                <a:spcPct val="0"/>
              </a:spcBef>
              <a:defRPr/>
            </a:pPr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ea typeface="+mj-ea"/>
                <a:cs typeface="Arial" pitchFamily="34" charset="0"/>
              </a:rPr>
              <a:t>Table </a:t>
            </a: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S5</a:t>
            </a:r>
            <a:r>
              <a:rPr kumimoji="0" lang="en-US" altLang="zh-CN" sz="100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Bioethanol yields (% dry matter) released from yeast </a:t>
            </a:r>
            <a:r>
              <a:rPr kumimoji="0" lang="en-US" altLang="zh-CN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fermentation using total hexoses obtained from </a:t>
            </a:r>
            <a:r>
              <a:rPr kumimoji="0" lang="en-US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enzymatic hydrolysis</a:t>
            </a:r>
            <a:r>
              <a:rPr kumimoji="0" lang="en-US" sz="1000" i="0" u="none" strike="noStrike" kern="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co-supplied with 1% Tween-80 after</a:t>
            </a:r>
            <a:r>
              <a:rPr kumimoji="0" lang="en-US" sz="1000" i="0" u="none" strike="noStrike" kern="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three optimal pretreatments </a:t>
            </a:r>
            <a:r>
              <a:rPr kumimoji="0" lang="en-US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in four typical pairs of </a:t>
            </a:r>
            <a:r>
              <a:rPr kumimoji="0" lang="en-US" sz="1000" i="1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Miscanthus</a:t>
            </a:r>
            <a:r>
              <a:rPr kumimoji="0" lang="en-US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accessions.</a:t>
            </a:r>
            <a:endParaRPr kumimoji="0" lang="zh-CN" altLang="en-US" sz="10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7" name="标题 3"/>
          <p:cNvSpPr txBox="1">
            <a:spLocks/>
          </p:cNvSpPr>
          <p:nvPr/>
        </p:nvSpPr>
        <p:spPr>
          <a:xfrm>
            <a:off x="685800" y="4419600"/>
            <a:ext cx="7772400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900" dirty="0" smtClean="0">
                <a:latin typeface="Arial" pitchFamily="34" charset="0"/>
                <a:cs typeface="Arial" pitchFamily="34" charset="0"/>
              </a:rPr>
              <a:t>* and ** as significant difference between two samples of each pair by t-test at </a:t>
            </a:r>
            <a:r>
              <a:rPr lang="en-US" sz="900" i="1" dirty="0" smtClean="0">
                <a:latin typeface="Arial" pitchFamily="34" charset="0"/>
                <a:cs typeface="Arial" pitchFamily="34" charset="0"/>
              </a:rPr>
              <a:t>P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&lt; 0.05 and &lt; 0.01 (n = 3); 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900" dirty="0">
                <a:latin typeface="Arial" pitchFamily="34" charset="0"/>
                <a:cs typeface="Arial" pitchFamily="34" charset="0"/>
              </a:rPr>
              <a:t>H) and (L) represented two samples of each pair showing relatively high (H) and low (L) biomass saccharification. The data as means ± SD</a:t>
            </a:r>
            <a:r>
              <a:rPr lang="en-US" altLang="zh-CN" sz="900" dirty="0" smtClean="0">
                <a:latin typeface="Arial" pitchFamily="34" charset="0"/>
                <a:cs typeface="Arial" pitchFamily="34" charset="0"/>
              </a:rPr>
              <a:t>.</a:t>
            </a:r>
            <a:endParaRPr lang="en-US" altLang="zh-CN" sz="9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438803743"/>
              </p:ext>
            </p:extLst>
          </p:nvPr>
        </p:nvGraphicFramePr>
        <p:xfrm>
          <a:off x="457200" y="857816"/>
          <a:ext cx="8077199" cy="3558448"/>
        </p:xfrm>
        <a:graphic>
          <a:graphicData uri="http://schemas.openxmlformats.org/drawingml/2006/table">
            <a:tbl>
              <a:tblPr/>
              <a:tblGrid>
                <a:gridCol w="1271412"/>
                <a:gridCol w="1420989"/>
                <a:gridCol w="1346200"/>
                <a:gridCol w="1346200"/>
                <a:gridCol w="1346200"/>
                <a:gridCol w="1346198"/>
              </a:tblGrid>
              <a:tr h="28975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ir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ample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aw</a:t>
                      </a:r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material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HW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O</a:t>
                      </a:r>
                      <a:r>
                        <a:rPr lang="en-US" sz="1000" b="1" i="0" u="none" strike="noStrike" baseline="-250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ptimal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aOH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43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i69 (H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0.00±0.54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27±0.86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99±0.26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5.24±1.9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1 (L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.25±2.2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.54±2.27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5.90±2.3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19±2.3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800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26 (H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.19±1.5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5.81±1.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90±2.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87±0.24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sa01 (L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45±1.04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1.75±0.57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.71±2.7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94±3.03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800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I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11 (H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.70±0.90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68±1.90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77±1.91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41±2.8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7 (L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79±2.26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2.54±2.40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60±2.3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10±2.64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8001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343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V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u02 (H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.99±0.82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91±0.8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7.39±0.66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.68±2.78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43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fl13 (L) 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.53±1.5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.25±2.80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5.15±2.16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.24±4.29</a:t>
                      </a:r>
                    </a:p>
                  </a:txBody>
                  <a:tcPr marL="7130" marR="7130" marT="71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标题 3"/>
          <p:cNvSpPr txBox="1">
            <a:spLocks/>
          </p:cNvSpPr>
          <p:nvPr/>
        </p:nvSpPr>
        <p:spPr>
          <a:xfrm>
            <a:off x="381000" y="228600"/>
            <a:ext cx="8229600" cy="609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 algn="just">
              <a:spcBef>
                <a:spcPct val="0"/>
              </a:spcBef>
              <a:defRPr/>
            </a:pPr>
            <a:r>
              <a:rPr lang="en-US" altLang="zh-CN" sz="1000" b="1" dirty="0" smtClean="0">
                <a:solidFill>
                  <a:srgbClr val="000000"/>
                </a:solidFill>
                <a:latin typeface="Arial" pitchFamily="34" charset="0"/>
                <a:ea typeface="+mj-ea"/>
                <a:cs typeface="Arial" pitchFamily="34" charset="0"/>
              </a:rPr>
              <a:t>Table </a:t>
            </a:r>
            <a:r>
              <a:rPr kumimoji="0" lang="en-US" altLang="zh-CN" sz="10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S6</a:t>
            </a:r>
            <a:r>
              <a:rPr kumimoji="0" lang="en-US" altLang="zh-CN" sz="100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Sugar-</a:t>
            </a:r>
            <a:r>
              <a:rPr lang="en-US" altLang="zh-CN" sz="1000" noProof="0" dirty="0" smtClean="0">
                <a:solidFill>
                  <a:srgbClr val="000000"/>
                </a:solidFill>
                <a:latin typeface="Arial" pitchFamily="34" charset="0"/>
                <a:ea typeface="+mj-ea"/>
                <a:cs typeface="Arial" pitchFamily="34" charset="0"/>
              </a:rPr>
              <a:t>e</a:t>
            </a:r>
            <a:r>
              <a:rPr kumimoji="0" lang="en-US" altLang="zh-CN" sz="100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thanol</a:t>
            </a:r>
            <a:r>
              <a:rPr kumimoji="0" lang="en-US" altLang="zh-CN" sz="100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conversion rates </a:t>
            </a:r>
            <a:r>
              <a:rPr kumimoji="0" lang="en-US" altLang="zh-CN" sz="1000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(%) based on the calculation</a:t>
            </a:r>
            <a:r>
              <a:rPr kumimoji="0" lang="en-US" altLang="zh-CN" sz="1000" i="0" u="none" strike="noStrike" kern="1200" cap="none" spc="0" normalizeH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 of total hexoses and ethanol yields obtained from three optimal  pretreatments as shown in Table S4 and S5 </a:t>
            </a:r>
            <a:r>
              <a:rPr kumimoji="0" lang="en-US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itchFamily="34" charset="0"/>
                <a:ea typeface="+mj-ea"/>
                <a:cs typeface="Arial" pitchFamily="34" charset="0"/>
              </a:rPr>
              <a:t>.</a:t>
            </a:r>
            <a:endParaRPr kumimoji="0" lang="zh-CN" altLang="en-US" sz="10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3"/>
          <p:cNvSpPr>
            <a:spLocks noGrp="1"/>
          </p:cNvSpPr>
          <p:nvPr>
            <p:ph type="title"/>
          </p:nvPr>
        </p:nvSpPr>
        <p:spPr>
          <a:xfrm>
            <a:off x="987582" y="381000"/>
            <a:ext cx="7010400" cy="4572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able S7-1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Wall polymer levels (% dry matter) of raw materials and </a:t>
            </a:r>
            <a:r>
              <a:rPr lang="en-US" altLang="zh-CN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he biomass residues obtained 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fter </a:t>
            </a:r>
            <a:r>
              <a:rPr lang="en-US" altLang="zh-CN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hree optimal pretreatments</a:t>
            </a:r>
            <a:endParaRPr lang="zh-CN" altLang="en-US" sz="1000" dirty="0" smtClean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标题 3"/>
          <p:cNvSpPr txBox="1">
            <a:spLocks/>
          </p:cNvSpPr>
          <p:nvPr/>
        </p:nvSpPr>
        <p:spPr>
          <a:xfrm>
            <a:off x="987582" y="5486400"/>
            <a:ext cx="70104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altLang="zh-CN" sz="900" dirty="0">
                <a:latin typeface="Times New Roman" pitchFamily="18" charset="0"/>
                <a:cs typeface="Times New Roman" pitchFamily="18" charset="0"/>
              </a:rPr>
              <a:t>The data as means ± </a:t>
            </a:r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SD (n = 3).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* and ** as significant difference between raw material and pretreated residue by t-test at </a:t>
            </a:r>
            <a:r>
              <a:rPr lang="en-US" sz="900" i="1" dirty="0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&lt; 0.05 and &lt; 0.01.</a:t>
            </a:r>
            <a:endParaRPr kumimoji="0" lang="zh-CN" altLang="en-US" sz="9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857047776"/>
              </p:ext>
            </p:extLst>
          </p:nvPr>
        </p:nvGraphicFramePr>
        <p:xfrm>
          <a:off x="1066800" y="838197"/>
          <a:ext cx="6858000" cy="4628253"/>
        </p:xfrm>
        <a:graphic>
          <a:graphicData uri="http://schemas.openxmlformats.org/drawingml/2006/table">
            <a:tbl>
              <a:tblPr/>
              <a:tblGrid>
                <a:gridCol w="609600"/>
                <a:gridCol w="1066800"/>
                <a:gridCol w="1447800"/>
                <a:gridCol w="1219200"/>
                <a:gridCol w="1295400"/>
                <a:gridCol w="1219200"/>
              </a:tblGrid>
              <a:tr h="3622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ir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ample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ptimal Pretreatment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llulose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emicelluloses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gnin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259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si69 (H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7.22±0.58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.90±0.72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.90±0.18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5.55±0.78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97±0.22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99±0.13*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8.58±1.70*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46±0.2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42±0.04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5.51±0.69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18±0.2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.38±1.19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lu01 (L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.34±1.34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.34±0.39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.74±1.49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3.92±1.26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33±0.15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76±0.44*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6.88±0.5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81±0.2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.53±0.50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4.28±1.1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89±0.16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.34±0.6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lu26 (H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.44±0.76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9.10±0.78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.36±0.03 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0.27±0.35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50±0.1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36±0.20 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0.72±0.96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29±0.2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26±0.2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0.89±0.7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58±0.28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62±0.20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sa01 (L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.12±1.45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9.36±0.37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.65±0.34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7.27±1.46*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06±0.2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11±0.13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7.77±0.5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21±0.1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55±0.7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7.58±1.0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17±0.6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.81±1.7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2276190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3"/>
          <p:cNvSpPr>
            <a:spLocks noGrp="1"/>
          </p:cNvSpPr>
          <p:nvPr>
            <p:ph type="title"/>
          </p:nvPr>
        </p:nvSpPr>
        <p:spPr>
          <a:xfrm>
            <a:off x="978057" y="381000"/>
            <a:ext cx="7162800" cy="457200"/>
          </a:xfrm>
        </p:spPr>
        <p:txBody>
          <a:bodyPr>
            <a:normAutofit/>
          </a:bodyPr>
          <a:lstStyle/>
          <a:p>
            <a:pPr algn="just"/>
            <a:r>
              <a:rPr lang="en-US" altLang="zh-CN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able S7-2 </a:t>
            </a:r>
            <a:r>
              <a:rPr lang="en-US" altLang="zh-CN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Wall polymer levels (% dry 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atter) of raw materials </a:t>
            </a:r>
            <a:r>
              <a:rPr lang="en-US" altLang="zh-CN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nd the biomass residues obtained </a:t>
            </a:r>
            <a:r>
              <a:rPr lang="en-US" altLang="zh-CN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fter </a:t>
            </a:r>
            <a:r>
              <a:rPr lang="en-US" altLang="zh-CN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three optimal pretreatments</a:t>
            </a:r>
            <a:endParaRPr lang="zh-CN" altLang="en-US" sz="1000" dirty="0" smtClean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标题 3"/>
          <p:cNvSpPr txBox="1">
            <a:spLocks/>
          </p:cNvSpPr>
          <p:nvPr/>
        </p:nvSpPr>
        <p:spPr>
          <a:xfrm>
            <a:off x="987582" y="5410200"/>
            <a:ext cx="7010400" cy="33972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altLang="zh-CN" sz="900" dirty="0">
                <a:latin typeface="Times New Roman" pitchFamily="18" charset="0"/>
                <a:cs typeface="Times New Roman" pitchFamily="18" charset="0"/>
              </a:rPr>
              <a:t>The data as means ± </a:t>
            </a:r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SD (n = 3).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* and ** as significant difference between raw material and pretreated residue by t-test at </a:t>
            </a:r>
            <a:r>
              <a:rPr lang="en-US" sz="900" i="1" dirty="0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US" sz="900" dirty="0" smtClean="0">
                <a:latin typeface="Times New Roman" pitchFamily="18" charset="0"/>
                <a:cs typeface="Times New Roman" pitchFamily="18" charset="0"/>
              </a:rPr>
              <a:t>&lt; 0.05 and &lt; 0.01.</a:t>
            </a:r>
            <a:endParaRPr kumimoji="0" lang="zh-CN" altLang="en-US" sz="9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066800" y="838197"/>
          <a:ext cx="6781800" cy="4628253"/>
        </p:xfrm>
        <a:graphic>
          <a:graphicData uri="http://schemas.openxmlformats.org/drawingml/2006/table">
            <a:tbl>
              <a:tblPr/>
              <a:tblGrid>
                <a:gridCol w="609600"/>
                <a:gridCol w="1143000"/>
                <a:gridCol w="1371600"/>
                <a:gridCol w="1219200"/>
                <a:gridCol w="1219200"/>
                <a:gridCol w="1219200"/>
              </a:tblGrid>
              <a:tr h="3622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ir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ample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ptimal Pretreatment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ellulose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emicelluloses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gnin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6259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II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lu11 (H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.51±0.93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.46±0.33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.01±0.33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6.07±1.11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00±0.18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35±0.35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.33±1.20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52±0.32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39±0.66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8.43±0.8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35±0.2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.90±0.36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fl17 (L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7.10±0.85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7.37±0.34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.47±0.15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5.80±0.40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57±0.05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27±0.45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1.79±0.95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79±0.08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50±0.72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7.32±1.6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79±0.40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.92±0.96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rowSpan="9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V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lu02 (H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.69±0.18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9.01±0.30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.23±0.56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8.14±1.18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19±0.32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73±0.43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4.78±0.4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31±0.1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82±0.37*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3.43±0.62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47±0.2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48±0.27** 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5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fl13 (L)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w material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.28±0.95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9.45±0.15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.24±0.08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HW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1.28±0.17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73±0.1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62±0.40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625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O</a:t>
                      </a:r>
                      <a:r>
                        <a:rPr lang="en-US" sz="1000" b="1" i="0" u="none" strike="noStrike" baseline="-2500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4.71±1.9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67±0.14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97±0.34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1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aOH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8.37±1.22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.24±0.21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73±0.47** </a:t>
                      </a:r>
                    </a:p>
                  </a:txBody>
                  <a:tcPr marL="6923" marR="6923" marT="69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1320513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28</TotalTime>
  <Words>3955</Words>
  <Application>Microsoft Office PowerPoint</Application>
  <PresentationFormat>On-screen Show (4:3)</PresentationFormat>
  <Paragraphs>1501</Paragraphs>
  <Slides>20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Additional Materials for ‘Biotechnology for Biofuels’</vt:lpstr>
      <vt:lpstr>Slide 2</vt:lpstr>
      <vt:lpstr>Slide 3</vt:lpstr>
      <vt:lpstr>Slide 4</vt:lpstr>
      <vt:lpstr>Table S4 Hexose yields (% cellulose) released from enzymatic hydrolysis co-supplied with 1% Tween-80  after three optimal pretreatments in four typical pairs of Miscanthus accessions. </vt:lpstr>
      <vt:lpstr>Slide 6</vt:lpstr>
      <vt:lpstr>Slide 7</vt:lpstr>
      <vt:lpstr>Table S7-1 Wall polymer levels (% dry matter) of raw materials and the biomass residues obtained after three optimal pretreatments</vt:lpstr>
      <vt:lpstr>Table S7-2 Wall polymer levels (% dry matter) of raw materials and the biomass residues obtained after three optimal pretreatments</vt:lpstr>
      <vt:lpstr>Table S8 Cellulose features (CrI and DP) of raw materials and the biomass residues obtained from three optimal pretreatments</vt:lpstr>
      <vt:lpstr>Table S9 Hemicellulose monosaccharides composition of raw materials and the biomass residues obtained from three optimal pretreatments</vt:lpstr>
      <vt:lpstr>Table S10 Three monomer ratios of lignin in raw materials and the biomass residues obtained from three optimal pretreatments</vt:lpstr>
      <vt:lpstr>Table S11 Characteristic bands of the FTIR spectra in biomass residues as referred from previous studies</vt:lpstr>
      <vt:lpstr>Table S12-1 Biomass porosity of raw materials and the biomass residues obtained from three optimal pretreatments in four pairs of Miscanthus accessions including Simons stains (DY, DB, Total, Y/B), Congo red dye (CR) and mixed-cellulase enzyme adsorption (Emax)</vt:lpstr>
      <vt:lpstr>Table S12-2 Biomass porosity of raw materials and the biomass residues obtained from three optimal pretreatments in four pairs of Miscanthus accessions including Simons stains (DY, DB, Total, Y/B), Congo red dye (CR) and mixed-cellulase enzyme adsorption (Emax)</vt:lpstr>
      <vt:lpstr>Slide 16</vt:lpstr>
      <vt:lpstr>Slide 17</vt:lpstr>
      <vt:lpstr>Table S15 Correlation coefficients (Spearman rank) between hexose/ethanol yields and major wall polymers features in four pairs of Miscanthus samples</vt:lpstr>
      <vt:lpstr>Table S16 Correlation coefficients (Spearman rank) among major wall polymer features and major factors of biomass porosity in four pairs of Miscanthus samples</vt:lpstr>
      <vt:lpstr>Slide 20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ftabAlam</dc:creator>
  <cp:lastModifiedBy>Aftab</cp:lastModifiedBy>
  <cp:revision>360</cp:revision>
  <cp:lastPrinted>2018-04-21T13:41:32Z</cp:lastPrinted>
  <dcterms:created xsi:type="dcterms:W3CDTF">2006-08-16T00:00:00Z</dcterms:created>
  <dcterms:modified xsi:type="dcterms:W3CDTF">2019-04-23T03:11:45Z</dcterms:modified>
</cp:coreProperties>
</file>